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83" r:id="rId2"/>
    <p:sldId id="271" r:id="rId3"/>
    <p:sldId id="273" r:id="rId4"/>
    <p:sldId id="285" r:id="rId5"/>
    <p:sldId id="286" r:id="rId6"/>
    <p:sldId id="287" r:id="rId7"/>
    <p:sldId id="288" r:id="rId8"/>
    <p:sldId id="282" r:id="rId9"/>
    <p:sldId id="289" r:id="rId10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337D628-8C33-6A46-9F08-D206A646F233}" v="16" dt="2025-08-26T13:54:02.606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1728"/>
    <p:restoredTop sz="96218"/>
  </p:normalViewPr>
  <p:slideViewPr>
    <p:cSldViewPr snapToGrid="0">
      <p:cViewPr varScale="1">
        <p:scale>
          <a:sx n="89" d="100"/>
          <a:sy n="89" d="100"/>
        </p:scale>
        <p:origin x="180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microsoft.com/office/2016/11/relationships/changesInfo" Target="changesInfos/changesInfo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agaraja, Ramaiah (NIH/NIA/IRP) [E]" userId="f89c9427-765f-4e55-a46c-7529201ca414" providerId="ADAL" clId="{B904E490-F98E-5FE7-871C-A20461132D79}"/>
    <pc:docChg chg="undo custSel addSld modSld sldOrd">
      <pc:chgData name="Nagaraja, Ramaiah (NIH/NIA/IRP) [E]" userId="f89c9427-765f-4e55-a46c-7529201ca414" providerId="ADAL" clId="{B904E490-F98E-5FE7-871C-A20461132D79}" dt="2025-08-26T13:54:13.403" v="145"/>
      <pc:docMkLst>
        <pc:docMk/>
      </pc:docMkLst>
      <pc:sldChg chg="addSp delSp modSp new mod ord">
        <pc:chgData name="Nagaraja, Ramaiah (NIH/NIA/IRP) [E]" userId="f89c9427-765f-4e55-a46c-7529201ca414" providerId="ADAL" clId="{B904E490-F98E-5FE7-871C-A20461132D79}" dt="2025-08-26T13:54:13.403" v="145"/>
        <pc:sldMkLst>
          <pc:docMk/>
          <pc:sldMk cId="886525378" sldId="289"/>
        </pc:sldMkLst>
        <pc:spChg chg="add del mod">
          <ac:chgData name="Nagaraja, Ramaiah (NIH/NIA/IRP) [E]" userId="f89c9427-765f-4e55-a46c-7529201ca414" providerId="ADAL" clId="{B904E490-F98E-5FE7-871C-A20461132D79}" dt="2025-08-26T13:15:53.731" v="16"/>
          <ac:spMkLst>
            <pc:docMk/>
            <pc:sldMk cId="886525378" sldId="289"/>
            <ac:spMk id="2" creationId="{65137DCC-24B5-6D19-98FF-B7631B847559}"/>
          </ac:spMkLst>
        </pc:spChg>
        <pc:spChg chg="add mod">
          <ac:chgData name="Nagaraja, Ramaiah (NIH/NIA/IRP) [E]" userId="f89c9427-765f-4e55-a46c-7529201ca414" providerId="ADAL" clId="{B904E490-F98E-5FE7-871C-A20461132D79}" dt="2025-08-26T13:35:53.426" v="103" actId="1036"/>
          <ac:spMkLst>
            <pc:docMk/>
            <pc:sldMk cId="886525378" sldId="289"/>
            <ac:spMk id="3" creationId="{57EE03D6-B651-CEFB-C33D-1AD2CB9B2DE2}"/>
          </ac:spMkLst>
        </pc:spChg>
        <pc:spChg chg="add mod">
          <ac:chgData name="Nagaraja, Ramaiah (NIH/NIA/IRP) [E]" userId="f89c9427-765f-4e55-a46c-7529201ca414" providerId="ADAL" clId="{B904E490-F98E-5FE7-871C-A20461132D79}" dt="2025-08-26T13:36:04.702" v="108" actId="1036"/>
          <ac:spMkLst>
            <pc:docMk/>
            <pc:sldMk cId="886525378" sldId="289"/>
            <ac:spMk id="5" creationId="{B6A365C7-B3F6-2AA0-AB61-3FA81C107B80}"/>
          </ac:spMkLst>
        </pc:spChg>
        <pc:spChg chg="add del mod">
          <ac:chgData name="Nagaraja, Ramaiah (NIH/NIA/IRP) [E]" userId="f89c9427-765f-4e55-a46c-7529201ca414" providerId="ADAL" clId="{B904E490-F98E-5FE7-871C-A20461132D79}" dt="2025-08-26T13:17:26.383" v="23"/>
          <ac:spMkLst>
            <pc:docMk/>
            <pc:sldMk cId="886525378" sldId="289"/>
            <ac:spMk id="7" creationId="{8077F154-FE50-7E0B-93EF-0F0B2462E79F}"/>
          </ac:spMkLst>
        </pc:spChg>
        <pc:spChg chg="add mod">
          <ac:chgData name="Nagaraja, Ramaiah (NIH/NIA/IRP) [E]" userId="f89c9427-765f-4e55-a46c-7529201ca414" providerId="ADAL" clId="{B904E490-F98E-5FE7-871C-A20461132D79}" dt="2025-08-26T13:17:19.680" v="21" actId="20577"/>
          <ac:spMkLst>
            <pc:docMk/>
            <pc:sldMk cId="886525378" sldId="289"/>
            <ac:spMk id="8" creationId="{AC08E2FD-4C20-8D9B-86B1-84A2CF88D41D}"/>
          </ac:spMkLst>
        </pc:spChg>
        <pc:spChg chg="add del mod">
          <ac:chgData name="Nagaraja, Ramaiah (NIH/NIA/IRP) [E]" userId="f89c9427-765f-4e55-a46c-7529201ca414" providerId="ADAL" clId="{B904E490-F98E-5FE7-871C-A20461132D79}" dt="2025-08-26T13:33:16.833" v="77" actId="478"/>
          <ac:spMkLst>
            <pc:docMk/>
            <pc:sldMk cId="886525378" sldId="289"/>
            <ac:spMk id="9" creationId="{D9539D9B-4989-7F74-287A-CA337A8B70DE}"/>
          </ac:spMkLst>
        </pc:spChg>
        <pc:spChg chg="add mod">
          <ac:chgData name="Nagaraja, Ramaiah (NIH/NIA/IRP) [E]" userId="f89c9427-765f-4e55-a46c-7529201ca414" providerId="ADAL" clId="{B904E490-F98E-5FE7-871C-A20461132D79}" dt="2025-08-26T13:33:06.748" v="76" actId="1038"/>
          <ac:spMkLst>
            <pc:docMk/>
            <pc:sldMk cId="886525378" sldId="289"/>
            <ac:spMk id="11" creationId="{F364BF3D-22B1-0793-420F-BDDE6A46B3C3}"/>
          </ac:spMkLst>
        </pc:spChg>
        <pc:spChg chg="add mod">
          <ac:chgData name="Nagaraja, Ramaiah (NIH/NIA/IRP) [E]" userId="f89c9427-765f-4e55-a46c-7529201ca414" providerId="ADAL" clId="{B904E490-F98E-5FE7-871C-A20461132D79}" dt="2025-08-26T13:34:50.669" v="85" actId="20577"/>
          <ac:spMkLst>
            <pc:docMk/>
            <pc:sldMk cId="886525378" sldId="289"/>
            <ac:spMk id="14" creationId="{E52228FA-9BB8-5384-C336-308904F2027D}"/>
          </ac:spMkLst>
        </pc:spChg>
        <pc:spChg chg="add mod">
          <ac:chgData name="Nagaraja, Ramaiah (NIH/NIA/IRP) [E]" userId="f89c9427-765f-4e55-a46c-7529201ca414" providerId="ADAL" clId="{B904E490-F98E-5FE7-871C-A20461132D79}" dt="2025-08-26T13:34:25.870" v="83"/>
          <ac:spMkLst>
            <pc:docMk/>
            <pc:sldMk cId="886525378" sldId="289"/>
            <ac:spMk id="15" creationId="{1286A2FD-F452-CBA2-E20B-04E848B74975}"/>
          </ac:spMkLst>
        </pc:spChg>
        <pc:spChg chg="add mod">
          <ac:chgData name="Nagaraja, Ramaiah (NIH/NIA/IRP) [E]" userId="f89c9427-765f-4e55-a46c-7529201ca414" providerId="ADAL" clId="{B904E490-F98E-5FE7-871C-A20461132D79}" dt="2025-08-26T13:35:18.740" v="88" actId="20577"/>
          <ac:spMkLst>
            <pc:docMk/>
            <pc:sldMk cId="886525378" sldId="289"/>
            <ac:spMk id="16" creationId="{8E4DDC5B-2F46-B559-C799-86E949EA87AC}"/>
          </ac:spMkLst>
        </pc:spChg>
        <pc:spChg chg="add mod">
          <ac:chgData name="Nagaraja, Ramaiah (NIH/NIA/IRP) [E]" userId="f89c9427-765f-4e55-a46c-7529201ca414" providerId="ADAL" clId="{B904E490-F98E-5FE7-871C-A20461132D79}" dt="2025-08-26T13:40:24.545" v="136" actId="1076"/>
          <ac:spMkLst>
            <pc:docMk/>
            <pc:sldMk cId="886525378" sldId="289"/>
            <ac:spMk id="17" creationId="{74119C64-2C0A-A29F-3044-6C8F0CEAD10F}"/>
          </ac:spMkLst>
        </pc:spChg>
        <pc:spChg chg="add del mod">
          <ac:chgData name="Nagaraja, Ramaiah (NIH/NIA/IRP) [E]" userId="f89c9427-765f-4e55-a46c-7529201ca414" providerId="ADAL" clId="{B904E490-F98E-5FE7-871C-A20461132D79}" dt="2025-08-26T13:53:42.374" v="140"/>
          <ac:spMkLst>
            <pc:docMk/>
            <pc:sldMk cId="886525378" sldId="289"/>
            <ac:spMk id="20" creationId="{DE0FB217-3913-930A-7E80-D6424DE37012}"/>
          </ac:spMkLst>
        </pc:spChg>
        <pc:spChg chg="add mod">
          <ac:chgData name="Nagaraja, Ramaiah (NIH/NIA/IRP) [E]" userId="f89c9427-765f-4e55-a46c-7529201ca414" providerId="ADAL" clId="{B904E490-F98E-5FE7-871C-A20461132D79}" dt="2025-08-26T13:53:35.096" v="138"/>
          <ac:spMkLst>
            <pc:docMk/>
            <pc:sldMk cId="886525378" sldId="289"/>
            <ac:spMk id="22" creationId="{FEF68A7E-40C8-F507-328E-D2D2A4022306}"/>
          </ac:spMkLst>
        </pc:spChg>
        <pc:spChg chg="add mod">
          <ac:chgData name="Nagaraja, Ramaiah (NIH/NIA/IRP) [E]" userId="f89c9427-765f-4e55-a46c-7529201ca414" providerId="ADAL" clId="{B904E490-F98E-5FE7-871C-A20461132D79}" dt="2025-08-26T13:53:35.096" v="138"/>
          <ac:spMkLst>
            <pc:docMk/>
            <pc:sldMk cId="886525378" sldId="289"/>
            <ac:spMk id="23" creationId="{0C709991-4F65-D045-41EC-20600E00782C}"/>
          </ac:spMkLst>
        </pc:spChg>
        <pc:spChg chg="add mod">
          <ac:chgData name="Nagaraja, Ramaiah (NIH/NIA/IRP) [E]" userId="f89c9427-765f-4e55-a46c-7529201ca414" providerId="ADAL" clId="{B904E490-F98E-5FE7-871C-A20461132D79}" dt="2025-08-26T13:53:35.096" v="138"/>
          <ac:spMkLst>
            <pc:docMk/>
            <pc:sldMk cId="886525378" sldId="289"/>
            <ac:spMk id="25" creationId="{F10C5210-3BF6-F20A-AE5B-59E0AF88DA95}"/>
          </ac:spMkLst>
        </pc:spChg>
        <pc:spChg chg="add mod">
          <ac:chgData name="Nagaraja, Ramaiah (NIH/NIA/IRP) [E]" userId="f89c9427-765f-4e55-a46c-7529201ca414" providerId="ADAL" clId="{B904E490-F98E-5FE7-871C-A20461132D79}" dt="2025-08-26T13:53:35.096" v="138"/>
          <ac:spMkLst>
            <pc:docMk/>
            <pc:sldMk cId="886525378" sldId="289"/>
            <ac:spMk id="27" creationId="{1CF90675-4DA7-3ABA-3E98-FE0227EC0280}"/>
          </ac:spMkLst>
        </pc:spChg>
        <pc:spChg chg="add del mod">
          <ac:chgData name="Nagaraja, Ramaiah (NIH/NIA/IRP) [E]" userId="f89c9427-765f-4e55-a46c-7529201ca414" providerId="ADAL" clId="{B904E490-F98E-5FE7-871C-A20461132D79}" dt="2025-08-26T13:54:13.403" v="145"/>
          <ac:spMkLst>
            <pc:docMk/>
            <pc:sldMk cId="886525378" sldId="289"/>
            <ac:spMk id="30" creationId="{45882D33-5DE9-1593-8A16-BDED1883212A}"/>
          </ac:spMkLst>
        </pc:spChg>
        <pc:spChg chg="add mod">
          <ac:chgData name="Nagaraja, Ramaiah (NIH/NIA/IRP) [E]" userId="f89c9427-765f-4e55-a46c-7529201ca414" providerId="ADAL" clId="{B904E490-F98E-5FE7-871C-A20461132D79}" dt="2025-08-26T13:54:09.618" v="143" actId="20577"/>
          <ac:spMkLst>
            <pc:docMk/>
            <pc:sldMk cId="886525378" sldId="289"/>
            <ac:spMk id="31" creationId="{25BFEB86-00D6-F41A-9BF9-B6E09B11B626}"/>
          </ac:spMkLst>
        </pc:spChg>
        <pc:picChg chg="add mod">
          <ac:chgData name="Nagaraja, Ramaiah (NIH/NIA/IRP) [E]" userId="f89c9427-765f-4e55-a46c-7529201ca414" providerId="ADAL" clId="{B904E490-F98E-5FE7-871C-A20461132D79}" dt="2025-08-26T13:32:37.260" v="27" actId="14100"/>
          <ac:picMkLst>
            <pc:docMk/>
            <pc:sldMk cId="886525378" sldId="289"/>
            <ac:picMk id="2" creationId="{3168D9CD-8AE7-5367-AE01-570975570E85}"/>
          </ac:picMkLst>
        </pc:picChg>
        <pc:picChg chg="add mod">
          <ac:chgData name="Nagaraja, Ramaiah (NIH/NIA/IRP) [E]" userId="f89c9427-765f-4e55-a46c-7529201ca414" providerId="ADAL" clId="{B904E490-F98E-5FE7-871C-A20461132D79}" dt="2025-08-26T13:15:29.622" v="10" actId="14100"/>
          <ac:picMkLst>
            <pc:docMk/>
            <pc:sldMk cId="886525378" sldId="289"/>
            <ac:picMk id="4" creationId="{AD1B86DD-0440-5073-9F6B-88D9C4E0D6D8}"/>
          </ac:picMkLst>
        </pc:picChg>
        <pc:picChg chg="add del mod">
          <ac:chgData name="Nagaraja, Ramaiah (NIH/NIA/IRP) [E]" userId="f89c9427-765f-4e55-a46c-7529201ca414" providerId="ADAL" clId="{B904E490-F98E-5FE7-871C-A20461132D79}" dt="2025-08-26T13:38:08.122" v="131" actId="478"/>
          <ac:picMkLst>
            <pc:docMk/>
            <pc:sldMk cId="886525378" sldId="289"/>
            <ac:picMk id="6" creationId="{F74D4157-6C44-98D5-0B9C-C7C818A76CA2}"/>
          </ac:picMkLst>
        </pc:picChg>
        <pc:picChg chg="add mod">
          <ac:chgData name="Nagaraja, Ramaiah (NIH/NIA/IRP) [E]" userId="f89c9427-765f-4e55-a46c-7529201ca414" providerId="ADAL" clId="{B904E490-F98E-5FE7-871C-A20461132D79}" dt="2025-08-26T13:40:13.572" v="135" actId="1076"/>
          <ac:picMkLst>
            <pc:docMk/>
            <pc:sldMk cId="886525378" sldId="289"/>
            <ac:picMk id="19" creationId="{7DC9342B-FD87-C7CB-A774-2F47512D03C7}"/>
          </ac:picMkLst>
        </pc:picChg>
        <pc:picChg chg="add mod">
          <ac:chgData name="Nagaraja, Ramaiah (NIH/NIA/IRP) [E]" userId="f89c9427-765f-4e55-a46c-7529201ca414" providerId="ADAL" clId="{B904E490-F98E-5FE7-871C-A20461132D79}" dt="2025-08-26T13:53:35.096" v="138"/>
          <ac:picMkLst>
            <pc:docMk/>
            <pc:sldMk cId="886525378" sldId="289"/>
            <ac:picMk id="21" creationId="{8B848FB5-DA1B-AC0E-2D07-C26C933A7253}"/>
          </ac:picMkLst>
        </pc:picChg>
        <pc:cxnChg chg="add del mod">
          <ac:chgData name="Nagaraja, Ramaiah (NIH/NIA/IRP) [E]" userId="f89c9427-765f-4e55-a46c-7529201ca414" providerId="ADAL" clId="{B904E490-F98E-5FE7-871C-A20461132D79}" dt="2025-08-26T13:33:21.361" v="78" actId="478"/>
          <ac:cxnSpMkLst>
            <pc:docMk/>
            <pc:sldMk cId="886525378" sldId="289"/>
            <ac:cxnSpMk id="7" creationId="{6978B57B-EDE9-86A0-C35B-C48ACE71B748}"/>
          </ac:cxnSpMkLst>
        </pc:cxnChg>
        <pc:cxnChg chg="add mod">
          <ac:chgData name="Nagaraja, Ramaiah (NIH/NIA/IRP) [E]" userId="f89c9427-765f-4e55-a46c-7529201ca414" providerId="ADAL" clId="{B904E490-F98E-5FE7-871C-A20461132D79}" dt="2025-08-26T13:32:49.528" v="48" actId="1038"/>
          <ac:cxnSpMkLst>
            <pc:docMk/>
            <pc:sldMk cId="886525378" sldId="289"/>
            <ac:cxnSpMk id="10" creationId="{3A84A4A5-40D9-6A0C-600A-81AACD666384}"/>
          </ac:cxnSpMkLst>
        </pc:cxnChg>
        <pc:cxnChg chg="add mod">
          <ac:chgData name="Nagaraja, Ramaiah (NIH/NIA/IRP) [E]" userId="f89c9427-765f-4e55-a46c-7529201ca414" providerId="ADAL" clId="{B904E490-F98E-5FE7-871C-A20461132D79}" dt="2025-08-26T13:32:37.260" v="27" actId="14100"/>
          <ac:cxnSpMkLst>
            <pc:docMk/>
            <pc:sldMk cId="886525378" sldId="289"/>
            <ac:cxnSpMk id="12" creationId="{F4B81B6E-8F95-5BC8-82FB-372847E78529}"/>
          </ac:cxnSpMkLst>
        </pc:cxnChg>
        <pc:cxnChg chg="add mod">
          <ac:chgData name="Nagaraja, Ramaiah (NIH/NIA/IRP) [E]" userId="f89c9427-765f-4e55-a46c-7529201ca414" providerId="ADAL" clId="{B904E490-F98E-5FE7-871C-A20461132D79}" dt="2025-08-26T13:32:37.260" v="27" actId="14100"/>
          <ac:cxnSpMkLst>
            <pc:docMk/>
            <pc:sldMk cId="886525378" sldId="289"/>
            <ac:cxnSpMk id="13" creationId="{893DFDE1-222C-2459-CF78-0E5B8D5CF171}"/>
          </ac:cxnSpMkLst>
        </pc:cxnChg>
        <pc:cxnChg chg="add mod">
          <ac:chgData name="Nagaraja, Ramaiah (NIH/NIA/IRP) [E]" userId="f89c9427-765f-4e55-a46c-7529201ca414" providerId="ADAL" clId="{B904E490-F98E-5FE7-871C-A20461132D79}" dt="2025-08-26T13:53:35.096" v="138"/>
          <ac:cxnSpMkLst>
            <pc:docMk/>
            <pc:sldMk cId="886525378" sldId="289"/>
            <ac:cxnSpMk id="24" creationId="{EA08F486-47CA-A261-6992-321594E166BC}"/>
          </ac:cxnSpMkLst>
        </pc:cxnChg>
        <pc:cxnChg chg="add mod">
          <ac:chgData name="Nagaraja, Ramaiah (NIH/NIA/IRP) [E]" userId="f89c9427-765f-4e55-a46c-7529201ca414" providerId="ADAL" clId="{B904E490-F98E-5FE7-871C-A20461132D79}" dt="2025-08-26T13:53:35.096" v="138"/>
          <ac:cxnSpMkLst>
            <pc:docMk/>
            <pc:sldMk cId="886525378" sldId="289"/>
            <ac:cxnSpMk id="26" creationId="{9767A093-7793-EB4E-B55B-7C84021C820E}"/>
          </ac:cxnSpMkLst>
        </pc:cxnChg>
        <pc:cxnChg chg="add mod">
          <ac:chgData name="Nagaraja, Ramaiah (NIH/NIA/IRP) [E]" userId="f89c9427-765f-4e55-a46c-7529201ca414" providerId="ADAL" clId="{B904E490-F98E-5FE7-871C-A20461132D79}" dt="2025-08-26T13:53:35.096" v="138"/>
          <ac:cxnSpMkLst>
            <pc:docMk/>
            <pc:sldMk cId="886525378" sldId="289"/>
            <ac:cxnSpMk id="28" creationId="{5D821501-101E-D468-F360-85CD58D05D4F}"/>
          </ac:cxnSpMkLst>
        </pc:cxnChg>
        <pc:cxnChg chg="add mod">
          <ac:chgData name="Nagaraja, Ramaiah (NIH/NIA/IRP) [E]" userId="f89c9427-765f-4e55-a46c-7529201ca414" providerId="ADAL" clId="{B904E490-F98E-5FE7-871C-A20461132D79}" dt="2025-08-26T13:53:35.096" v="138"/>
          <ac:cxnSpMkLst>
            <pc:docMk/>
            <pc:sldMk cId="886525378" sldId="289"/>
            <ac:cxnSpMk id="29" creationId="{AB1803C3-E36A-BE7E-A0D0-1348405990FA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3A450-0731-FC4F-9DF9-C647F306AC61}" type="datetimeFigureOut">
              <a:rPr lang="en-US" smtClean="0"/>
              <a:t>8/26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F8221-9195-424B-A946-EAFB3E3FA3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86586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3A450-0731-FC4F-9DF9-C647F306AC61}" type="datetimeFigureOut">
              <a:rPr lang="en-US" smtClean="0"/>
              <a:t>8/26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F8221-9195-424B-A946-EAFB3E3FA3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68651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3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3A450-0731-FC4F-9DF9-C647F306AC61}" type="datetimeFigureOut">
              <a:rPr lang="en-US" smtClean="0"/>
              <a:t>8/26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F8221-9195-424B-A946-EAFB3E3FA3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0016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3A450-0731-FC4F-9DF9-C647F306AC61}" type="datetimeFigureOut">
              <a:rPr lang="en-US" smtClean="0"/>
              <a:t>8/26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F8221-9195-424B-A946-EAFB3E3FA3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24908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3A450-0731-FC4F-9DF9-C647F306AC61}" type="datetimeFigureOut">
              <a:rPr lang="en-US" smtClean="0"/>
              <a:t>8/26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F8221-9195-424B-A946-EAFB3E3FA3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81005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3A450-0731-FC4F-9DF9-C647F306AC61}" type="datetimeFigureOut">
              <a:rPr lang="en-US" smtClean="0"/>
              <a:t>8/26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F8221-9195-424B-A946-EAFB3E3FA3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44133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5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3A450-0731-FC4F-9DF9-C647F306AC61}" type="datetimeFigureOut">
              <a:rPr lang="en-US" smtClean="0"/>
              <a:t>8/26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F8221-9195-424B-A946-EAFB3E3FA3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5940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3A450-0731-FC4F-9DF9-C647F306AC61}" type="datetimeFigureOut">
              <a:rPr lang="en-US" smtClean="0"/>
              <a:t>8/26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F8221-9195-424B-A946-EAFB3E3FA3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11668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3A450-0731-FC4F-9DF9-C647F306AC61}" type="datetimeFigureOut">
              <a:rPr lang="en-US" smtClean="0"/>
              <a:t>8/26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F8221-9195-424B-A946-EAFB3E3FA3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41392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8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3A450-0731-FC4F-9DF9-C647F306AC61}" type="datetimeFigureOut">
              <a:rPr lang="en-US" smtClean="0"/>
              <a:t>8/26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F8221-9195-424B-A946-EAFB3E3FA3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76391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8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53A450-0731-FC4F-9DF9-C647F306AC61}" type="datetimeFigureOut">
              <a:rPr lang="en-US" smtClean="0"/>
              <a:t>8/26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F8221-9195-424B-A946-EAFB3E3FA3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4586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53A450-0731-FC4F-9DF9-C647F306AC61}" type="datetimeFigureOut">
              <a:rPr lang="en-US" smtClean="0"/>
              <a:t>8/26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FF8221-9195-424B-A946-EAFB3E3FA3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5204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nagarajar@grc.nia.nih.gov" TargetMode="Externa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6DFDE55-4A12-4754-45F0-314AD0D4339C}"/>
              </a:ext>
            </a:extLst>
          </p:cNvPr>
          <p:cNvSpPr txBox="1"/>
          <p:nvPr/>
        </p:nvSpPr>
        <p:spPr>
          <a:xfrm>
            <a:off x="362608" y="446948"/>
            <a:ext cx="6143296" cy="769973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ctr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endParaRPr lang="en-US" b="1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algn="ctr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alysis of a novel human protein, ORF3, encoded by spacer rDNA</a:t>
            </a:r>
            <a:endParaRPr lang="en-US" sz="1100" b="1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algn="ctr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Yaohui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hen</a:t>
            </a: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Jung-Hyun Kim</a:t>
            </a: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ee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Sheung Lee</a:t>
            </a: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Sergey Koren</a:t>
            </a: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Vladimir Larionov</a:t>
            </a: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Adam M.     Phillippy</a:t>
            </a: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David Schlessinger</a:t>
            </a: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and Ramaiah Nagaraja</a:t>
            </a: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 *</a:t>
            </a:r>
            <a:endParaRPr lang="en-US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US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aboratory of Genetics and Genomics, National Institute on Aging, National Institutes of Health Intramural Research Program (NIH IRP), Baltimore, MD 21224, USA. </a:t>
            </a: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velopmental Therapeutics Branch, National Cancer Institute (NCI), NIH IRP, Bethesda, MD 20892, USA. </a:t>
            </a: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nome Informatics Section, Center for Genomics and Data Science Research, National Human Genome Research Institute, National Institutes of Health, Bethesda, MD 20892</a:t>
            </a: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Correspondence:</a:t>
            </a: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aboratory of Genetics and Genomics</a:t>
            </a: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iomedical Research Center</a:t>
            </a: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ational Institute on Aging, National Institutes of Health</a:t>
            </a: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51 Bayview Blvd.</a:t>
            </a: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altimore, MD 21224, USA</a:t>
            </a: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u="sng" dirty="0">
                <a:solidFill>
                  <a:srgbClr val="0000FF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nagarajar@grc.nia.nih.gov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</a:p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unning title: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ibosomin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s encoded by spacer rDNA</a:t>
            </a:r>
            <a:b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U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6D82E48-CC1C-59C8-C9DA-2149EBA8B196}"/>
              </a:ext>
            </a:extLst>
          </p:cNvPr>
          <p:cNvSpPr txBox="1"/>
          <p:nvPr/>
        </p:nvSpPr>
        <p:spPr>
          <a:xfrm>
            <a:off x="4276844" y="83130"/>
            <a:ext cx="25811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orting Material, Chen et al page 1</a:t>
            </a:r>
          </a:p>
        </p:txBody>
      </p:sp>
    </p:spTree>
    <p:extLst>
      <p:ext uri="{BB962C8B-B14F-4D97-AF65-F5344CB8AC3E}">
        <p14:creationId xmlns:p14="http://schemas.microsoft.com/office/powerpoint/2010/main" val="38251397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36E25054-6308-25B6-D935-682F82B333D5}"/>
              </a:ext>
            </a:extLst>
          </p:cNvPr>
          <p:cNvSpPr txBox="1"/>
          <p:nvPr/>
        </p:nvSpPr>
        <p:spPr>
          <a:xfrm>
            <a:off x="4572681" y="2013329"/>
            <a:ext cx="837089" cy="1789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63" b="1" dirty="0">
                <a:latin typeface="Arial" panose="020B0604020202020204" pitchFamily="34" charset="0"/>
                <a:cs typeface="Arial" panose="020B0604020202020204" pitchFamily="34" charset="0"/>
              </a:rPr>
              <a:t>Chen et al., Fig. S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A899DBC-3B79-F4A3-F02D-42E0206E4110}"/>
              </a:ext>
            </a:extLst>
          </p:cNvPr>
          <p:cNvSpPr txBox="1"/>
          <p:nvPr/>
        </p:nvSpPr>
        <p:spPr>
          <a:xfrm>
            <a:off x="1567257" y="2085111"/>
            <a:ext cx="258404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88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6A9B99E-B7A8-0542-65DA-D9139E51E5F0}"/>
              </a:ext>
            </a:extLst>
          </p:cNvPr>
          <p:cNvSpPr txBox="1"/>
          <p:nvPr/>
        </p:nvSpPr>
        <p:spPr>
          <a:xfrm>
            <a:off x="1567257" y="4650294"/>
            <a:ext cx="258404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88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FDD1E9CA-BFEA-9A1E-A028-E7D68BAFC5E8}"/>
              </a:ext>
            </a:extLst>
          </p:cNvPr>
          <p:cNvGrpSpPr/>
          <p:nvPr/>
        </p:nvGrpSpPr>
        <p:grpSpPr>
          <a:xfrm>
            <a:off x="500269" y="715618"/>
            <a:ext cx="5857461" cy="4347044"/>
            <a:chOff x="379785" y="399210"/>
            <a:chExt cx="6156655" cy="4172790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65890D0A-661E-9B10-AB42-B7ADB016B77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9785" y="399210"/>
              <a:ext cx="6156655" cy="4172790"/>
            </a:xfrm>
            <a:prstGeom prst="rect">
              <a:avLst/>
            </a:prstGeom>
          </p:spPr>
        </p:pic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7062380F-34A7-4B50-8433-DCF484E40A60}"/>
                </a:ext>
              </a:extLst>
            </p:cNvPr>
            <p:cNvSpPr/>
            <p:nvPr/>
          </p:nvSpPr>
          <p:spPr>
            <a:xfrm>
              <a:off x="4963391" y="2416367"/>
              <a:ext cx="207818" cy="277528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/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1DBCB8A9-A4D7-CEFE-9CA6-C49B85D52725}"/>
                </a:ext>
              </a:extLst>
            </p:cNvPr>
            <p:cNvSpPr txBox="1"/>
            <p:nvPr/>
          </p:nvSpPr>
          <p:spPr>
            <a:xfrm>
              <a:off x="4933739" y="2362200"/>
              <a:ext cx="207817" cy="3797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88" dirty="0">
                  <a:latin typeface="Symbol" pitchFamily="2" charset="2"/>
                </a:rPr>
                <a:t>D</a:t>
              </a:r>
            </a:p>
          </p:txBody>
        </p:sp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2CFE6E72-BF89-4F33-3F31-545B0F3234B2}"/>
                </a:ext>
              </a:extLst>
            </p:cNvPr>
            <p:cNvSpPr/>
            <p:nvPr/>
          </p:nvSpPr>
          <p:spPr>
            <a:xfrm>
              <a:off x="5184909" y="2514599"/>
              <a:ext cx="207818" cy="233757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/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94164EE6-22CB-092D-6AEE-62E793097587}"/>
                </a:ext>
              </a:extLst>
            </p:cNvPr>
            <p:cNvSpPr txBox="1"/>
            <p:nvPr/>
          </p:nvSpPr>
          <p:spPr>
            <a:xfrm>
              <a:off x="5171211" y="2455711"/>
              <a:ext cx="223593" cy="3797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88" dirty="0"/>
                <a:t>I</a:t>
              </a:r>
            </a:p>
          </p:txBody>
        </p:sp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id="{02C224B8-04C7-C30E-AF34-FFB260A745B2}"/>
              </a:ext>
            </a:extLst>
          </p:cNvPr>
          <p:cNvGrpSpPr/>
          <p:nvPr/>
        </p:nvGrpSpPr>
        <p:grpSpPr>
          <a:xfrm>
            <a:off x="500269" y="5159179"/>
            <a:ext cx="5857461" cy="3737113"/>
            <a:chOff x="381000" y="4832666"/>
            <a:chExt cx="6034193" cy="4311334"/>
          </a:xfrm>
        </p:grpSpPr>
        <p:pic>
          <p:nvPicPr>
            <p:cNvPr id="9" name="Picture 8" descr="A picture containing text, stationary, writing implement, pencil&#10;&#10;Description automatically generated">
              <a:extLst>
                <a:ext uri="{FF2B5EF4-FFF2-40B4-BE49-F238E27FC236}">
                  <a16:creationId xmlns:a16="http://schemas.microsoft.com/office/drawing/2014/main" id="{56F4D041-E8D6-38B5-88A4-7869BEB2896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1000" y="4832666"/>
              <a:ext cx="6034193" cy="4311334"/>
            </a:xfrm>
            <a:prstGeom prst="rect">
              <a:avLst/>
            </a:prstGeom>
          </p:spPr>
        </p:pic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26884DD6-6E9E-B110-B4CF-617F373BCCDA}"/>
                </a:ext>
              </a:extLst>
            </p:cNvPr>
            <p:cNvSpPr/>
            <p:nvPr/>
          </p:nvSpPr>
          <p:spPr>
            <a:xfrm>
              <a:off x="2204999" y="7579956"/>
              <a:ext cx="55320" cy="457200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0F699FAA-B851-A319-BD90-E086A071B720}"/>
                </a:ext>
              </a:extLst>
            </p:cNvPr>
            <p:cNvSpPr/>
            <p:nvPr/>
          </p:nvSpPr>
          <p:spPr>
            <a:xfrm>
              <a:off x="1752600" y="8035985"/>
              <a:ext cx="55320" cy="16024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13"/>
            </a:p>
          </p:txBody>
        </p:sp>
      </p:grpSp>
      <p:sp>
        <p:nvSpPr>
          <p:cNvPr id="13" name="TextBox 12">
            <a:extLst>
              <a:ext uri="{FF2B5EF4-FFF2-40B4-BE49-F238E27FC236}">
                <a16:creationId xmlns:a16="http://schemas.microsoft.com/office/drawing/2014/main" id="{2B2EBAB7-982F-1C35-4426-31C7C9BDFA33}"/>
              </a:ext>
            </a:extLst>
          </p:cNvPr>
          <p:cNvSpPr txBox="1"/>
          <p:nvPr/>
        </p:nvSpPr>
        <p:spPr>
          <a:xfrm>
            <a:off x="4276844" y="83130"/>
            <a:ext cx="25811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orting Material, Chen et al page 2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349D6BF-CDF9-E4D6-F29C-29116585BAB3}"/>
              </a:ext>
            </a:extLst>
          </p:cNvPr>
          <p:cNvSpPr txBox="1"/>
          <p:nvPr/>
        </p:nvSpPr>
        <p:spPr>
          <a:xfrm>
            <a:off x="5538408" y="333535"/>
            <a:ext cx="13195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hen et al., Fig. S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381D1EC-C506-31C2-7BF6-6FACB904CD21}"/>
              </a:ext>
            </a:extLst>
          </p:cNvPr>
          <p:cNvSpPr txBox="1"/>
          <p:nvPr/>
        </p:nvSpPr>
        <p:spPr>
          <a:xfrm>
            <a:off x="501603" y="436098"/>
            <a:ext cx="3516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52A5692-B641-FDD1-42D9-C69DC868447F}"/>
              </a:ext>
            </a:extLst>
          </p:cNvPr>
          <p:cNvSpPr txBox="1"/>
          <p:nvPr/>
        </p:nvSpPr>
        <p:spPr>
          <a:xfrm>
            <a:off x="499698" y="4931898"/>
            <a:ext cx="3516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1980495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2C2B357F-5D2D-FED1-9994-69F6C242B3BB}"/>
              </a:ext>
            </a:extLst>
          </p:cNvPr>
          <p:cNvGrpSpPr/>
          <p:nvPr/>
        </p:nvGrpSpPr>
        <p:grpSpPr>
          <a:xfrm>
            <a:off x="231227" y="2192289"/>
            <a:ext cx="6442841" cy="4860152"/>
            <a:chOff x="1500188" y="3226297"/>
            <a:chExt cx="3857625" cy="2691408"/>
          </a:xfrm>
        </p:grpSpPr>
        <p:pic>
          <p:nvPicPr>
            <p:cNvPr id="2" name="Predicted Secondary Structure.mp4">
              <a:hlinkClick r:id="" action="ppaction://media"/>
              <a:extLst>
                <a:ext uri="{FF2B5EF4-FFF2-40B4-BE49-F238E27FC236}">
                  <a16:creationId xmlns:a16="http://schemas.microsoft.com/office/drawing/2014/main" id="{6C8A9E59-E944-FDC4-C86F-500D941E3C16}"/>
                </a:ext>
              </a:extLst>
            </p:cNvPr>
            <p:cNvPicPr>
              <a:picLocks noChangeAspect="1"/>
            </p:cNvPicPr>
            <p:nvPr>
              <a:videoFile r:link="rId2"/>
              <p:extLst>
                <p:ext uri="{DAA4B4D4-6D71-4841-9C94-3DE7FCFB9230}">
                  <p14:media xmlns:p14="http://schemas.microsoft.com/office/powerpoint/2010/main" r:embed="rId1"/>
                </p:ext>
              </p:extLst>
            </p:nvPr>
          </p:nvPicPr>
          <p:blipFill>
            <a:blip r:embed="rId4"/>
            <a:stretch>
              <a:fillRect/>
            </a:stretch>
          </p:blipFill>
          <p:spPr>
            <a:xfrm>
              <a:off x="1500188" y="3226297"/>
              <a:ext cx="3857625" cy="2691408"/>
            </a:xfrm>
            <a:prstGeom prst="rect">
              <a:avLst/>
            </a:prstGeom>
            <a:solidFill>
              <a:schemeClr val="tx1"/>
            </a:solidFill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1A3D35E8-906E-E097-C7E8-ECD7846E1757}"/>
                </a:ext>
              </a:extLst>
            </p:cNvPr>
            <p:cNvSpPr txBox="1"/>
            <p:nvPr/>
          </p:nvSpPr>
          <p:spPr>
            <a:xfrm>
              <a:off x="3871222" y="4529139"/>
              <a:ext cx="776175" cy="2482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13" dirty="0"/>
                <a:t>N-Terminal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99637CE6-A0EF-8C08-6E45-03FE0E54CAA0}"/>
                </a:ext>
              </a:extLst>
            </p:cNvPr>
            <p:cNvSpPr txBox="1"/>
            <p:nvPr/>
          </p:nvSpPr>
          <p:spPr>
            <a:xfrm>
              <a:off x="4114801" y="5223421"/>
              <a:ext cx="761747" cy="2482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13" dirty="0"/>
                <a:t>C-Terminal</a:t>
              </a:r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54EFEAA0-7999-CEC0-7BC7-7A91F7674CA0}"/>
              </a:ext>
            </a:extLst>
          </p:cNvPr>
          <p:cNvSpPr txBox="1"/>
          <p:nvPr/>
        </p:nvSpPr>
        <p:spPr>
          <a:xfrm>
            <a:off x="5253486" y="360129"/>
            <a:ext cx="14205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en et al., Fig. S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1655864-0AE1-F244-AD87-0B05D4CED327}"/>
              </a:ext>
            </a:extLst>
          </p:cNvPr>
          <p:cNvSpPr txBox="1"/>
          <p:nvPr/>
        </p:nvSpPr>
        <p:spPr>
          <a:xfrm>
            <a:off x="4276844" y="83130"/>
            <a:ext cx="25811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orting Material, Chen et al page 3</a:t>
            </a:r>
          </a:p>
        </p:txBody>
      </p:sp>
    </p:spTree>
    <p:extLst>
      <p:ext uri="{BB962C8B-B14F-4D97-AF65-F5344CB8AC3E}">
        <p14:creationId xmlns:p14="http://schemas.microsoft.com/office/powerpoint/2010/main" val="1818533506"/>
      </p:ext>
    </p:extLst>
  </p:cSld>
  <p:clrMapOvr>
    <a:masterClrMapping/>
  </p:clrMapOvr>
  <p:timing>
    <p:tnLst>
      <p:par>
        <p:cTn id="1" dur="indefinite" restart="never" nodeType="tmRoot">
          <p:childTnLst>
            <p:video>
              <p:cMediaNode vol="80000">
                <p:cTn id="2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B34ECA9-43AA-25AC-92E4-F464DD87DB3E}"/>
              </a:ext>
            </a:extLst>
          </p:cNvPr>
          <p:cNvSpPr txBox="1"/>
          <p:nvPr/>
        </p:nvSpPr>
        <p:spPr>
          <a:xfrm>
            <a:off x="303785" y="476868"/>
            <a:ext cx="6255239" cy="86792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F3_transcript/1-2020      ---------------TCACCTAGCGGTCACTGTTACTCTGAAAACGGAGGCCTCACAGAG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Bonobo_GCA_029289425.2      ---------------TCACCTAGCGGTCACTGTGACTCTGAAAACGGAGGCCTCACAGAG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Gorilla_KX061887.1/1-2031   ---------------TCACCTAGCGGTCACTGTTACTCTGAAGACGGAGGCCTCACAGAG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angutan_KX061888.1/1-1908 TCACCTAGCGGCCACTCACCTAGCGGCCACTGTTGCTCTGAAAACGGAGGAAGCAC-CAG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Chimp_KX061886.1/1-2098     ---------------TCACCTAGCGGTCACTGTTACTCTGAAAACGGAGGCCTCACAGAG</a:t>
            </a:r>
          </a:p>
          <a:p>
            <a:endParaRPr lang="en-U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F3_transcript/1-2020      GAAGGGAGCACCAGGCCGCCTGCGCACAGCCTGGGGCAACTGTGTCTTCTCCACCGCCCC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Bonobo_GCA</a:t>
            </a:r>
            <a:r>
              <a:rPr lang="en-US" sz="900" b="0" i="0" dirty="0">
                <a:solidFill>
                  <a:srgbClr val="333333"/>
                </a:solidFill>
                <a:effectLst/>
                <a:highlight>
                  <a:srgbClr val="D3DFF5"/>
                </a:highlight>
                <a:latin typeface="Verdana" panose="020B0604030504040204" pitchFamily="34" charset="0"/>
              </a:rPr>
              <a:t>_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029289425.2      GAAGGGAGCACCAGGCCGCCTGCGCACAGCCTGGGGCAACTGTGTCTTCTCCACCGCCCC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Gorilla_KX061887.1/1-2031   GAAGGGAGCACCAGGCCGCCTGCGCA----------CAACTGTGTCTTCTCTACCGCCCC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angutan_KX061888.1/1-1908 GCCGGAAGCACCAGGCCGCCTGCGCGCAGCCTGGGGCAACTGTGTCTTCTCCACCG-CCC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Chimp_KX061886.1/1-2098     GAAGGGAGCACCAGGCCGCCTGCGCACAGCCTGGGGCAACTGTGTCTTCTCCACCGCCCC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                                   </a:t>
            </a:r>
            <a:r>
              <a:rPr lang="en-US" sz="900" b="1" dirty="0">
                <a:latin typeface="Courier New" panose="02070309020205020404" pitchFamily="49" charset="0"/>
                <a:cs typeface="Courier New" panose="02070309020205020404" pitchFamily="49" charset="0"/>
              </a:rPr>
              <a:t>| End Coding region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F3_transcript/1-2020      CGCCCCCACCTCCAAGTTCCTCCCTCCCTTGTTGC</a:t>
            </a:r>
            <a:r>
              <a:rPr lang="en-US" sz="900" b="1" i="1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TA</a:t>
            </a:r>
            <a:r>
              <a:rPr lang="en-US" sz="900" i="1" u="sng" dirty="0">
                <a:latin typeface="Courier New" panose="02070309020205020404" pitchFamily="49" charset="0"/>
                <a:cs typeface="Courier New" panose="02070309020205020404" pitchFamily="49" charset="0"/>
              </a:rPr>
              <a:t>GGAAATCGCCACTTTGACGACC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Bonobo_GCA_029289425.2      CGCCCCCACCTCCATGTTCCTCCCTCCTTTGTTGCCTAGGAAACCGCCACTTTGACGACT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Gorilla_KX061887.1/1-2031   CGCCCCCACCTCCAAGTTCCTCCCTCCCTTG-TGCCTAGGAAATCGCCACTTTGACGACT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angutan_KX061888.1/1-1908 CGCCCCCACCTCCAAGTTCCTCCCTCCCTCG-TGCCTAGGAAATCGCCACTTTGACGACT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Chimp_KX061886.1/1-2098     CACCCCCACCTCCAAGTTCCTCCCTCCTTTGTTGCCTAGGAAATCGCCACTTTGACGACT</a:t>
            </a:r>
          </a:p>
          <a:p>
            <a:endParaRPr lang="en-U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F3_transcript/1-2020      </a:t>
            </a:r>
            <a:r>
              <a:rPr lang="en-US" sz="900" i="1" u="sng" dirty="0">
                <a:latin typeface="Courier New" panose="02070309020205020404" pitchFamily="49" charset="0"/>
                <a:cs typeface="Courier New" panose="02070309020205020404" pitchFamily="49" charset="0"/>
              </a:rPr>
              <a:t>GGGTCTGATTGACCTTTGATCAGGCAAAAACGAACAAACAGATAAATAAATAAAATAACA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Bonobo_GCA_029289425.2      GGGTCTGATTGACCTTTGATCAGGCAAAAACGAACAAACAAATAAATAAATAAAATAACA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Gorilla_KX061887.1/1-2031   GGGTCTGATTGACCTTTGATCAGGCAAGAACGAACAAACAAATAAATAAATAAAATAACA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angutan_KX061888.1/1-1908 GGGTCTGATTGACCTTTGATCAGGCAAAAACAAGCAAACACATAAATAAATAGAATAACA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Chimp_KX061886.1/1-2098     GGGTCTGATTGACCTTTGATCAGGCAAAAACGAACAAACAAATAAATAAATAAAATAACA</a:t>
            </a:r>
          </a:p>
          <a:p>
            <a:endParaRPr lang="en-U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F3_transcript/1-2020      </a:t>
            </a:r>
            <a:r>
              <a:rPr lang="en-US" sz="900" i="1" u="sng" dirty="0">
                <a:latin typeface="Courier New" panose="02070309020205020404" pitchFamily="49" charset="0"/>
                <a:cs typeface="Courier New" panose="02070309020205020404" pitchFamily="49" charset="0"/>
              </a:rPr>
              <a:t>CAAAAGTAACTAACTAAATAAAATAAGTCAATACAACCCATTACAATACAATAAGATACG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Bonobo_GCA_029289425.2      CAAAAGTAACTAACTAAATAAAATAAGTCAATACAATCCATTGCAATGCAATAAAATACC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Gorilla_KX061887.1/1-2031   CCAAAGTAACTAACTAAATAAGATAAGCCATTACAATACAATACAATACGATACAACACG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angutan_KX061888.1/1-1908 CAGAAATAACTAACGAAATAAAATAAGTCAATACAATGCATTCCAATACAATACAATGCA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Chimp_KX061886.1/1-2098     CAAAAGTAACTAACTGAATAAAATAAGTCAATACAATCCATTGCAATGCAATAAAATACC</a:t>
            </a:r>
          </a:p>
          <a:p>
            <a:endParaRPr lang="en-U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F3_transcript/1-2020      </a:t>
            </a:r>
            <a:r>
              <a:rPr lang="en-US" sz="900" i="1" u="sng" dirty="0">
                <a:latin typeface="Courier New" panose="02070309020205020404" pitchFamily="49" charset="0"/>
                <a:cs typeface="Courier New" panose="02070309020205020404" pitchFamily="49" charset="0"/>
              </a:rPr>
              <a:t>ATACGATAGGATGCGATAG-------------GATACGATAGGATACAATACAATAGGAT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Bonobo/147-2191             ATACGATACGATAGGATAG-------------GATAGGATACGATACGATACGATACGAT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                 </a:t>
            </a:r>
            <a:r>
              <a:rPr lang="en-US" sz="900" b="1" dirty="0">
                <a:latin typeface="Courier New" panose="02070309020205020404" pitchFamily="49" charset="0"/>
                <a:cs typeface="Courier New" panose="02070309020205020404" pitchFamily="49" charset="0"/>
              </a:rPr>
              <a:t>Insertion in Gorilla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Gorilla_KX061887.1/1-2031   ATACGATAGGATACAGTAAATACAATAAATACAATACAATACAATACAATACAATACAAT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               </a:t>
            </a:r>
            <a:r>
              <a:rPr lang="en-US" sz="900" b="1" dirty="0">
                <a:latin typeface="Courier New" panose="02070309020205020404" pitchFamily="49" charset="0"/>
                <a:cs typeface="Courier New" panose="02070309020205020404" pitchFamily="49" charset="0"/>
              </a:rPr>
              <a:t>Deletions in Orangutan and Chimp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angutan_KX061888.1/1-1908 ACGCAACACAACACA-------------------------------------------AC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Chimp_KX061886.1/1-2098     ACACGATACGATA-----------------------------------------------</a:t>
            </a:r>
          </a:p>
          <a:p>
            <a:endParaRPr lang="en-U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F3_transcript/1-2020      </a:t>
            </a:r>
            <a:r>
              <a:rPr lang="en-US" sz="900" i="1" u="sng" dirty="0">
                <a:latin typeface="Courier New" panose="02070309020205020404" pitchFamily="49" charset="0"/>
                <a:cs typeface="Courier New" panose="02070309020205020404" pitchFamily="49" charset="0"/>
              </a:rPr>
              <a:t>ACGATACAATACAATACAATACAATACAATACAATACAATACAATACA</a:t>
            </a:r>
            <a:r>
              <a:rPr lang="en-US" sz="900" i="1" u="sng" dirty="0">
                <a:solidFill>
                  <a:schemeClr val="accent2">
                    <a:lumMod val="75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TACAATACAAT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Bonobo_GCA_029289425.2     ACGATACGATACGATACGATACAATACAATACAATACAATACAATACAATACAATACAAT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Gorilla_KX061887.1/1-2031   ACAATACAATACAATACAATACAATACAATACAATACAATACAATACAACACAACACAAT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angutan_KX061888.1/1-1908 GCAACGCTACACAACGCAACACAATACAATACAACGCAATACAATACAATACAATACAAC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Chimp_KX061886.1/1-2098     -----------GGATACAATACAATACAATACAATACAATACAATACAATACAATACAAT</a:t>
            </a:r>
          </a:p>
          <a:p>
            <a:endParaRPr lang="en-U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F3_transcript/1-2020      </a:t>
            </a:r>
            <a:r>
              <a:rPr lang="en-US" sz="900" i="1" u="sng" dirty="0">
                <a:solidFill>
                  <a:schemeClr val="accent2">
                    <a:lumMod val="75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CGCCGGGCGCGGTGGCTCATGCCTGTCATCCCGTCACTTTGGGATGCCGAGGTGGACGC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Bonobo/147-2191             AGGCCAGGCGCGGTGGCTCATGCCTGTCATCCCATCACTTTGGGAGGCCGAGGTGGACGC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Gorilla_KX061887.1/1-2031   AGGCCAGGCGCGGTGGCTCATGCCTGTCATCCCATCACTTTGGGATGCCGAGGTGGACGC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angutan_KX061888.1/1-1908 AGGCCGGGCGCGGTGGCTCATGCCTGTCATCCCATCACTTTGGGAGGCCGAGGTGGACGC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Chimp_KX061886.1/1-2098     AGGCCGGGTGCGGTGGCTCATGCCTGTCATCCCATCACTTTGGGAGGCCGAGGTGGACGC</a:t>
            </a:r>
          </a:p>
          <a:p>
            <a:endParaRPr lang="en-U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F3_transcript/1-2020      </a:t>
            </a:r>
            <a:r>
              <a:rPr lang="en-US" sz="900" i="1" u="sng" dirty="0">
                <a:solidFill>
                  <a:schemeClr val="accent2">
                    <a:lumMod val="75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TCACCTGAAGTCGGGAGTTGGAGACAAGCCCGACCAACATGGAGAAATCCCGTCTCAAT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Bonobo_GCA_029289425.2      ATCACCTGAAGTCGGGAGTTGGAGACAAGCCCGACCAACATGGAGAAATCCCGTCTCAAT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Gorilla_KX061887.1/1-2031   ATCACCTGAAGTCGGGAGTTGGAGACAAGCCCGACCAACATGGAGAAATCCCGTCTCAAT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angutan_KX061888.1/1-1908 ATCACCTGAAGTCGGGAGTCGGAGACAAGCCTGACCAACATGGGGAAATCCCGTCTC-AT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Chimp_KX061886.1/1-2098     ATCACCTGAAGTCGGGAGTTGGAGACAAGCCCGACCAACATGGAGAAATCCCGTCTCAAT</a:t>
            </a:r>
          </a:p>
          <a:p>
            <a:endParaRPr lang="en-U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F3_transcript/1-2020      </a:t>
            </a:r>
            <a:r>
              <a:rPr lang="en-US" sz="900" i="1" u="sng" dirty="0">
                <a:solidFill>
                  <a:schemeClr val="accent2">
                    <a:lumMod val="75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AAAATACAAAACTAGCCGGGCGCGGTGGCACATGCCTATAATCCCAGCTGCTAGGAAG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Bonobo_GCA_029289425.2      TGAAAATACAAAACTAGCCGGGCGCGGTGGCACATGCCTATAATCCCAGCTGCTAGGAAG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Gorilla_KX061887.1/1-2031   TGAAAATACAAAATTAGCCGGGCGTGGTGGCACATGCCTCTAATCCCAGCTGCTAGGAAG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angutan_KX061888.1/1-1908 TGAAAATACAAAATTAGCCGGGTGTGGTAGCGCATGCCTATAATCCCAGCTGCTAGGAAG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Chimp_KX061886.1/1-2098     TGAAAATACAAAACTAGCCGGGCGCGGTGGCACATGCCTATAATCCCAGCTGCTAGGAAG</a:t>
            </a:r>
          </a:p>
          <a:p>
            <a:endParaRPr lang="en-U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F29875C0-CE8A-D9D4-41CF-67AC6BF6782A}"/>
              </a:ext>
            </a:extLst>
          </p:cNvPr>
          <p:cNvSpPr/>
          <p:nvPr/>
        </p:nvSpPr>
        <p:spPr>
          <a:xfrm>
            <a:off x="3604590" y="5028030"/>
            <a:ext cx="901149" cy="148115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2A88C01-9EB4-540A-F7E7-B0B8C4D4EF9A}"/>
              </a:ext>
            </a:extLst>
          </p:cNvPr>
          <p:cNvSpPr txBox="1"/>
          <p:nvPr/>
        </p:nvSpPr>
        <p:spPr>
          <a:xfrm>
            <a:off x="4496571" y="341189"/>
            <a:ext cx="17187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Chen et al., Fig S3a Cont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36E9440-E9A9-B68F-60F3-9E8E7A61EAF9}"/>
              </a:ext>
            </a:extLst>
          </p:cNvPr>
          <p:cNvSpPr txBox="1"/>
          <p:nvPr/>
        </p:nvSpPr>
        <p:spPr>
          <a:xfrm>
            <a:off x="4065363" y="64190"/>
            <a:ext cx="25811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orting Material, Chen et al page 5</a:t>
            </a:r>
          </a:p>
        </p:txBody>
      </p:sp>
    </p:spTree>
    <p:extLst>
      <p:ext uri="{BB962C8B-B14F-4D97-AF65-F5344CB8AC3E}">
        <p14:creationId xmlns:p14="http://schemas.microsoft.com/office/powerpoint/2010/main" val="87435096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C12112CB-39F8-6C12-5D70-F97EBA66061F}"/>
              </a:ext>
            </a:extLst>
          </p:cNvPr>
          <p:cNvSpPr/>
          <p:nvPr/>
        </p:nvSpPr>
        <p:spPr>
          <a:xfrm>
            <a:off x="3453847" y="2583516"/>
            <a:ext cx="230257" cy="398221"/>
          </a:xfrm>
          <a:prstGeom prst="rect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2">
                  <a:lumMod val="20000"/>
                  <a:lumOff val="80000"/>
                </a:schemeClr>
              </a:solidFill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EA24D1A-4771-8790-3E77-F97A2566FC3F}"/>
              </a:ext>
            </a:extLst>
          </p:cNvPr>
          <p:cNvSpPr txBox="1"/>
          <p:nvPr/>
        </p:nvSpPr>
        <p:spPr>
          <a:xfrm>
            <a:off x="236982" y="603200"/>
            <a:ext cx="6409538" cy="84023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F3_transcript/1-2020      </a:t>
            </a:r>
            <a:r>
              <a:rPr lang="en-US" sz="900" i="1" u="sng" dirty="0">
                <a:solidFill>
                  <a:schemeClr val="accent2">
                    <a:lumMod val="75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CTGAGGCAGGAGAATCGCTTGAACCTGGGAAGCGGAGGTTGCAGTGAGCCGAGATTGCG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Bonobo_GCA_029289425.2      GCTGAGGCAGGAGAATCGCTTGAACCTGGGAAGCGGAGGGTGCGGTGAGCCGAGATTGCG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Gorilla_KX061887.1/1-2031   GCTGAGGCAGGAGAATCGCTTGAACCTGGGAAGCGGAGGTGGCGGTGAGCCGAGATTGCG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angutan_KX061888.1/1-1908 GCTGAGGCAGGAGAATCGCTTG-ACCTGGGAAGCGGAGGTTGCGGTGAGCCGAGATCGCG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Chimp_KX061886.1/1-2098     GCTGAGGCAGGAGAATCGCTTGAACCTGGGAAGCGGAGGTTGCGGTGAGCCGAGATTGCG</a:t>
            </a:r>
          </a:p>
          <a:p>
            <a:endParaRPr lang="en-U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F3_transcript/1-2020      </a:t>
            </a:r>
            <a:r>
              <a:rPr lang="en-US" sz="900" i="1" u="sng" dirty="0">
                <a:solidFill>
                  <a:schemeClr val="accent2">
                    <a:lumMod val="75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CATCGCACTCCAGTCTGAGCAACAAGAGCGAAACTCCGTCTCAAAAATAAATACATAAA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Bonobo_GCA_029289425.2      CCATCGCACTCCAGTCTGAGCAAAAAGAGCGAAACTCCGTCTCAAAAATAAATAAATAAA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Gorilla_KX061887.1/1-2031   CCATCGCACTCCAGTCTGAGCAACAAGAGCGAAACTCCGTCTCAAAG--AAATAAACTA-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angutan_KX061888.1/1-1908 CCATCGCACCCCAGTCTGAGCAACAAGAGCGAAACTCCGTCTCAGAA--AAATAAAATC-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Chimp_KX061886.1/1-2098     CCATCGCACTCCAGTCTGAGCAAAAACAGCGAAACTCCGTCTCAAAAATAAATAAATAAA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        </a:t>
            </a:r>
            <a:r>
              <a:rPr lang="en-US" sz="900" b="1" dirty="0">
                <a:latin typeface="Courier New" panose="02070309020205020404" pitchFamily="49" charset="0"/>
                <a:cs typeface="Courier New" panose="02070309020205020404" pitchFamily="49" charset="0"/>
              </a:rPr>
              <a:t>Begin Coding Region|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F3_transcript/1-2020      </a:t>
            </a:r>
            <a:r>
              <a:rPr lang="en-US" sz="900" i="1" u="sng" dirty="0">
                <a:latin typeface="Courier New" panose="02070309020205020404" pitchFamily="49" charset="0"/>
                <a:cs typeface="Courier New" panose="02070309020205020404" pitchFamily="49" charset="0"/>
              </a:rPr>
              <a:t>TAAATACATACATACATA</a:t>
            </a:r>
            <a:r>
              <a:rPr lang="en-US" sz="900" b="1" i="1" u="sng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AT</a:t>
            </a:r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ACATACATACATAAATTAAAATAAATAAATAAAATAAAA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Bonobo_GCA_029289           TACATACATACATAAATACAT------------AAATTAAAATAAATAAATACAATACAA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Gorilla_KX061887.1/1-2031   -----AGATAAATAAATAAATACATAAATACATAAATTAAAATAAATAAATAAA-TAAA-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angutan_KX061888.1/1-1908 -----------------AAATAAATAAACACATAAATGAAAATAAACAAAGAAAATAAAA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Chimp_KX061886.1/1-2098     TAAATAAATAAATAAATAAATACACAAATACATAAATTAAAATAAATAAATACAATGCAA</a:t>
            </a:r>
          </a:p>
          <a:p>
            <a:endParaRPr lang="en-U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F3_transcript/1-2020      TAAA-TAAA---------TGGGCCCTGCGCGGTGGCTCAAGCCTGTCATCCCCT-CACTT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Bonobo_GCA_029289425.2      TAAAATAAA---------TGGGCCCTGCGCGGTGGCTCAAGCCTGTCACCCCCT-CACTT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Gorilla_KX061887.1/1-2031   TAAAATAAAATAAATAAATGGGCCCTGCGCGGTGGCTCAAGCCTGTCATCCCCT-CACTT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angutan_KX061888.1/1-1908 TAAAGCAAACAAATA-----GGCCCCGCGCGGTGGCTCAAGCCTGTCATCGCCAGCACTT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Chimp_KX061886.1/1-2098     TAAAATAAA---------TGGGCCCTGCGCGGTGGCTCAAGCCTGTCA-CCCCAAATAAA</a:t>
            </a:r>
          </a:p>
          <a:p>
            <a:endParaRPr lang="en-U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F3_transcript/1-2020      TGGGAGGCCAAGGCCGGTGGAT--------------------------------------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Bonobo_GCA_029289425.2      TGGGAGGCCAAGGCCGGTGGAT--------------------------------------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Gorilla_KX061887.1/1-2031   TGGGAGGCCAAGGCCGGTGGAT--------------------------------------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angutan_KX061888.1/1-1908 TGGGCGGCCAAGGCCGGTGGAT--------------------------------------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Chimp_KX061886.1/1-2098     TAAAATAAAATAAATAAATGGGCCCTGCGCGGTGGCTCAAGCCTGTCATCCCCTCACTTT</a:t>
            </a:r>
          </a:p>
          <a:p>
            <a:endParaRPr lang="en-U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F3_transcript/1-2020      ---------------------CAAGAGGCGGTCAGACCAACAGGGCCAGTATGGTGAAAC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Bonobo_GCA_029289425.2      ---------------------CAAGAGGCGGTCAGACCAACAGGGCCAGTATGGTGAAAC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Gorilla_KX061887.1/1-2031   --------------CAAGAGGCAAGAGGCGGTCAGACCAACAGGGCCAGTATGGTGAAA-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angutan_KX061888.1/1-1908 ---------------------CACGAGGCGGTCAGACCAGCAGGGCCAGTATGGCGAAAC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Chimp_KX061886.1/1-2098     GGGAGGCCAAGGCCGGTGGATCAAGAGGCGGTCAGACCAACAGGGCCAGTATGGTGAAAC</a:t>
            </a:r>
          </a:p>
          <a:p>
            <a:endParaRPr lang="en-U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F3_transcript/1-2020      CCCGTCTCTACTCACAATACACAACATTAGCCGGGCGCTGTGCTGTGCTGTACTGTCTGT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Bonobo_GCA_029289425.2      CCCGTCTCTACTCACAATACACAAAATTAGCCGGGCGCCGTGCTGTGCTGTACTGTCTGT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Gorilla_KX061887.1/1-2031   -----------------CACACCAAATTAGCCGGGTGCCGTGCTGTGCTGTGCTGTCTGT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angutan_KX061888.1/1-1908 CCCATCTCTCCTCACAATACACAAAATTAGCCGGGC-----GCGGTGCTGTACTGTCTGT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Chimp_KX061886.1/1-2098     CCCGTCTCTACTCACAATACACAGAATTAGCCAGGCGCCGTGCTGTGCTGTACTGTCTGT</a:t>
            </a:r>
          </a:p>
          <a:p>
            <a:endParaRPr lang="en-U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F3_transcript/1-2020      AATCCCAGCTACTCGGGAGGCCGAGCTGAGGCAGGAGAATCGCTTGAACCTGGGAGGCGG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Bonobo_GCA_029289425.2      AATCCCAGCTACTCGGGAGGCCGAGCTGAGGCAGGAGAATCGCTTGAACCTGGGAGGTGG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Gorilla_KX061887.1/1-2031   AATCCCAGCTACTCGGGAGGCCGAGCTGAGGCAGGAGAATCGCTTGAACCTGGGAGGCGG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angutan_KX061888.1/1-1908 AATCCCAGCTACTCGGGAGGCCGAGCTGAGGCAGGGGAATCGCTTGAACCTGGGAGGCGG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Chimp_KX061886.1/1-2098     AATCCCAGCTACTCGGGAGGCCGAGCTGAGGCAGGAGAATCGCTTGAACCTGGGAGGTGG</a:t>
            </a:r>
          </a:p>
          <a:p>
            <a:endParaRPr lang="en-U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F3_transcript/1-2020      AGGTTGCAGTGAGCCGAGATCGCGCCACTGCAACCCAGCCTGGGCGACAGAGCGAGACTC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Bonobo_GCA_029289425.2      AGGTTGCAGTGAGCCGAGATCGTGCCACTGCACCCCAGCCTGGGCGACAGAGCGAGACTC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Gorilla_KX061887.1/1-2031   AGGGTGCAGTGAGCCGAGATCGCGCCACTGCACCCCAGCCTGGGCGACAGAGCGAGACTC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angutan_KX061888.1/1-1908 AGGTTGCGGTGAGCCGAGATCGCGCCACCGCACCCCAGCCTGGGCGACAGAGCGAGACTC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Chimp_KX061886.1/1-2098     AGGTTGCAGTGAGCCGAGATCGTGCCACTGCACCCCAGCCTGGGCGACAGAGCGAGACTC</a:t>
            </a:r>
          </a:p>
          <a:p>
            <a:endParaRPr lang="en-U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F3_transcript/1-2020      CGTCTCCAAAAAATGAAAATG------AAAATGAAACGCAACAAAATAATTAAAAAGTGA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Bonobo_GCA_029289425.2      CGTCTCAAAAAAATGAAAATG------AAAATGAAATGCAACAAAATAATTAAAAAGTGA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Gorilla_KX061887.1/1-2031   CGTCTCAAAAAAATGAAAATGAAAACAAAAATGAAATGCAACAAAATAATTAAAAAGTGA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angutan_KX061888.1/1-1908 CGTCTCAAAAAAAAGGAAAAT-----AAAACTGACATGAAAGAAAATACTTAAAAAGTGA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Chimp_KX061886.1/1-2098     CGTCTCAAAAAAATGAAAATG------AAAATGAAATGCAACAAAATAATTAAAAAGTG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2029D31-4DE4-3322-8153-F6EDAA590390}"/>
              </a:ext>
            </a:extLst>
          </p:cNvPr>
          <p:cNvSpPr txBox="1"/>
          <p:nvPr/>
        </p:nvSpPr>
        <p:spPr>
          <a:xfrm>
            <a:off x="4496571" y="380945"/>
            <a:ext cx="17187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Chen et al., Fig S3a Cont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0B3F01A-88B2-4F9D-A211-A0D3AFB623AF}"/>
              </a:ext>
            </a:extLst>
          </p:cNvPr>
          <p:cNvSpPr txBox="1"/>
          <p:nvPr/>
        </p:nvSpPr>
        <p:spPr>
          <a:xfrm>
            <a:off x="4065363" y="103946"/>
            <a:ext cx="25811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orting Material, Chen et al page 5</a:t>
            </a:r>
          </a:p>
        </p:txBody>
      </p:sp>
    </p:spTree>
    <p:extLst>
      <p:ext uri="{BB962C8B-B14F-4D97-AF65-F5344CB8AC3E}">
        <p14:creationId xmlns:p14="http://schemas.microsoft.com/office/powerpoint/2010/main" val="77455779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702932A8-FB58-C31D-B29B-441E80F45E34}"/>
              </a:ext>
            </a:extLst>
          </p:cNvPr>
          <p:cNvSpPr txBox="1"/>
          <p:nvPr/>
        </p:nvSpPr>
        <p:spPr>
          <a:xfrm>
            <a:off x="287866" y="644692"/>
            <a:ext cx="6282267" cy="66018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F3_transcript/1-2020      GTTTCTGGGGAAAAAGAAGAA-----------------AAGAAAAAAGAAAAAAACAACA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Bonobo_GCA_029289425.2      GTTTCCGGGGAAAAAGAAAAAACAACAACAACAACAACAACAACAACAACAACAACAACA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Gorilla_KX061887.1/1-2031   GTTTCCGGGAAAAAAGAAAAA----------------------AGGAAAAAAAAAAAAAA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angutan_KX061888.1/1-1908 GTTTCCGGGAAAAAAGAAAAA------------------------------AAAAAAAAA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Chimp_KX061886.1/1-2098     GTCTCCGGGGAAAAAGAAACAACAACAACAACAACAACAACAACAACAACAACAACAAAA</a:t>
            </a:r>
          </a:p>
          <a:p>
            <a:endParaRPr lang="en-U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F3_transcript/1-2020      AAACAGAACAACCCCACCGTGACATAC----ACGTACGCCTCTCGCCTTTCGAGGCCTCA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Bonobo_GCA_029289425.2      ACAAAAAACAACCCCACCGTGACATACACGTACGTACGCCTCTCGCCTTTCGAGGCATCA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Gorilla_KX061887.1/1-2031   GAAGAAAACAACCCCACCGTGACGTAC----ACATACGCCTCTCGCCTTTCCAGGCATCA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angutan_KX061888.1/1-1908 AAGAGAACCCCCCCCCCCACAGCGTAC----ACAGACCCCTCTCGCCTTTCGAGGCACCA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Chimp_KX061886.1/1-2098     AA------CAACCCCACCGTGACATCCACGTACGTACGCCTCTCGCCTTTCGAGGCATCA</a:t>
            </a:r>
          </a:p>
          <a:p>
            <a:endParaRPr lang="en-U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F3_transcript/1-2020      AACACGTTAGGAATTATGCGTGATTTC-TTTTTTTAACTTCATTTTATGTTATTATCATG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Bonobo_GCA_029289425.2      AACACGTTAGGAATTATGCGTGATTTCTTTTTTTTAACTTAATTTTATTTTATTATCATG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Gorilla_KX061887.1/1-2031   GACACGTTAGGAATCATGCGTGATTTC-TTTTTTTAACTTAATTTTATTTTATCATGATG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angutan_KX061888.1/1-1908 GACACGTTAGGAACGATGCGTACTTTC-TTTTTTTAACGGAATTTTATTTTATGAGCGGG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Chimp_KX061886.1/1-2098     AACACGTTAGGAATTATGCGTGATTTCTTTTTTTTAACTTAATTTTATTTTATTCTCATG</a:t>
            </a:r>
          </a:p>
          <a:p>
            <a:endParaRPr lang="en-U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F3_transcript/1-2020      ATTGATGTTTCCAGACGGAGTCTCGGAGGCCCGCCC--------------TCCCTGGTTG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Bonobo_GCA_029289425.2      ATTTATGTTTCGAGACGGAGTCTCGGAGGCCCGCCCTCCCTCCGTCCCATTCCCTGGTTG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Gorilla_KX061887.1/1-2031   ATTTATGTTTCGAGACGGAGTCTCGGAGGCCCGCCCTCCCTCCGTCCCATTCCCTGGTTG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angutan_KX061888.1/1-1908 ATTTGTTTTTCGAGACGGAGGTTCGGAGTCCCGCCCTCCCTCCGTCCCGGTCCCTGGTTG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Chimp_KX061886.1/1-2098     ATTTCTGTTTCGAGACGGAGTCTCGGAGGCCCGCCCTCCCTCCGTCCCATTCCCTGGTTG</a:t>
            </a:r>
          </a:p>
          <a:p>
            <a:endParaRPr lang="en-U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F3_transcript/1-2020      CCCAGACAACCCCGGGAGACAGACCCTGGCTGGGCCCGATTGTTCTTCTCCTTGGTCAGG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Bonobo_GCA_029289425.2      CCCAGACAACCTCAGGAGACAGACCCTGGCTGGGCCAGATTGTTCTTCTCCTCGGTCGAT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Gorilla_KX061887.1/1-2031   CCCAGACCACCTCAGGAGACAGACCCTGGCTGGGCCAGATTGTTCTTCTCCTTGGTCAAT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angutan_KX061888.1/1-1908 CCCGGACGACCTCAGGAGACAGACCCTGGCTGGGCCAGATGGTCCTTCTCCTTGGTCGGT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Chimp_KX061886.1/1-2098     CCCAGACAACCTCAGGAGACAGACCCTGGCTGGGCCAGATTGTTCTTCTCCTCGGTCGAT</a:t>
            </a:r>
          </a:p>
          <a:p>
            <a:endParaRPr lang="en-U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F3_transcript/1-2020      GGTTTCCTTG--------------TCTTTCTTCGTGTCTTTAACCCGCGTGGACTCTTCC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Bonobo_GCA_029289425.2      GGTTTCCTTG--------------TCTTTCTTCGTGTCTTTAACCCGCGTGGACTCTTCC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Gorilla_KX061887.1/1-2031   GGTTTCCTTG--------------TCTTTCTTCGTGTCTTTAACCCGCGTGGACGCTTCC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angutan_KX061888.1/1-1908 GGTTTCCTTGTGTTTCTTCGTGTCTGTTTCTTCGTGTCTTTAACCCGCGTGGACTCTTCT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Chimp_KX061886.1/1-2098     GGTTTCCTTG--------------TCTTTCTTCGTGTCTTTAACCCGCGTGGACTCTTCC</a:t>
            </a:r>
          </a:p>
          <a:p>
            <a:endParaRPr lang="en-U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F3_transcript/1-2020      GCTCGGGTTTGACAGATGGCAGCTCCACTTTAGGCCTTGTTGTTGTTGGGGACTTTCCTG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Bonobo_GCA_029289425.2      GCTCGGGTTTGACAGATGGCAGCTCCACTTTAGGCCTTGTTGTTGTTGGGGACTTTCCCG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Gorilla_KX061887.1/1-2031   GCTCGGGTTTTACAGATGGCAGCTCCACTTTAGGCCTTGTTGTTGTTGGGGACTTTCCTG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angutan_KX061888.1/1-1908 GCTCGGGTTT---------------TACTTTAGGCCTTGTCGTTGGTGGGGACTTTCCTG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Chimp_KX061886.1/1-2098     GCTCGGGTTTGACAGATGGCAGCTCCACTTTAGGCCTTGTTGTTGTTGGGGACTTTCCCG</a:t>
            </a:r>
          </a:p>
          <a:p>
            <a:endParaRPr lang="en-US" sz="9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F3_transcript/1-2020      ATTCTCCCCAGATGTAGTGAAAGCAGGTAG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Bonobo_GCA_029289425.2      ATTCTCCCCAGATGTAGGGAAAGCAGGTAG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Gorilla_KX061887.1/1-2031   ATTCTCCCCAGATGTAGTGAAAGCAGGTAG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orangutan_KX061888.1/1-1908 ATTCTCCCCGGATGTAGTGAAAGCGGGTAG</a:t>
            </a:r>
          </a:p>
          <a:p>
            <a:r>
              <a:rPr lang="en-US" sz="900" dirty="0">
                <a:latin typeface="Courier New" panose="02070309020205020404" pitchFamily="49" charset="0"/>
                <a:cs typeface="Courier New" panose="02070309020205020404" pitchFamily="49" charset="0"/>
              </a:rPr>
              <a:t>Chimp_KX061886.1/1-2098     ATTCTCCCCAGATGTAGTGAAAGCAGGTAG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5AD75D4-CCD9-BA1F-9D81-A41ED43C84D2}"/>
              </a:ext>
            </a:extLst>
          </p:cNvPr>
          <p:cNvSpPr txBox="1"/>
          <p:nvPr/>
        </p:nvSpPr>
        <p:spPr>
          <a:xfrm>
            <a:off x="4496571" y="380945"/>
            <a:ext cx="17187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Chen et al., Fig S3a Cont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1F77A94-99BD-64C4-0A2F-8DF197F1F5BC}"/>
              </a:ext>
            </a:extLst>
          </p:cNvPr>
          <p:cNvSpPr txBox="1"/>
          <p:nvPr/>
        </p:nvSpPr>
        <p:spPr>
          <a:xfrm>
            <a:off x="4065363" y="103946"/>
            <a:ext cx="25811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orting Material, Chen et al page 5</a:t>
            </a:r>
          </a:p>
        </p:txBody>
      </p:sp>
    </p:spTree>
    <p:extLst>
      <p:ext uri="{BB962C8B-B14F-4D97-AF65-F5344CB8AC3E}">
        <p14:creationId xmlns:p14="http://schemas.microsoft.com/office/powerpoint/2010/main" val="289773788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A11F84B1-0C1B-A757-4F6D-3452D9B99A7E}"/>
              </a:ext>
            </a:extLst>
          </p:cNvPr>
          <p:cNvSpPr txBox="1"/>
          <p:nvPr/>
        </p:nvSpPr>
        <p:spPr>
          <a:xfrm>
            <a:off x="432344" y="932743"/>
            <a:ext cx="6184352" cy="25632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  <a:p>
            <a:r>
              <a:rPr lang="en-US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Bonobo 1     MYLCMYVFIYLFLRRSFALFAQTGVRWRNLGSPHPPLPRFKRFSCLSLPSSWDYRHVPPR  60</a:t>
            </a:r>
          </a:p>
          <a:p>
            <a:r>
              <a:rPr lang="en-US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MY+CMY+F+YLFLRRSFAL AQTGVRWRNLGS  PPLPRFKRFSCLSLPSSWDYRHVPPR</a:t>
            </a:r>
          </a:p>
          <a:p>
            <a:r>
              <a:rPr lang="en-US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ORF3   1     MYVCMYLFMYLFLRRSFALVAQTGVRWRNLGSLQPPLPRFKRFSCLSLPSSWDYRHVPPR  60</a:t>
            </a:r>
          </a:p>
          <a:p>
            <a:endParaRPr 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Bonobo 61    PASFVFSIETGFLHVGRACLQLPTSGDASTSASQSDGMTGMSHRAWPIVLYCIVLYCIVL  120</a:t>
            </a:r>
          </a:p>
          <a:p>
            <a:r>
              <a:rPr lang="en-US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PASFVFSIETGFLHVGRACLQLPTSGDASTSASQSDGMTGMSHRA  IVLYCIVLYCIVL</a:t>
            </a:r>
          </a:p>
          <a:p>
            <a:r>
              <a:rPr lang="en-US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ORF3   61    PASFVFSIETGFLHVGRACLQLPTSGDASTSASQSDGMTGMSHRARRIVLYCIVLYCIVL  120</a:t>
            </a:r>
          </a:p>
          <a:p>
            <a:endParaRPr 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Bonobo 121   YRIVSYRIVSYRIVSYPILSYRMVFYCIAMDCIDLFYLVSYFCVILFIYLFVRFCLIKGQ  180</a:t>
            </a:r>
          </a:p>
          <a:p>
            <a:r>
              <a:rPr lang="en-US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Y IV YRI+ Y I+SYPI SYR+V YCI M CIDLFYLVSYFCVILFIYLFVRFCLIKGQ</a:t>
            </a:r>
          </a:p>
          <a:p>
            <a:r>
              <a:rPr lang="en-US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ORF3   121   YCIVLYRILLYCILSYPIASYRIVSYCIVMGCIDLFYLVSYFCVILFIYLFVRFCLIKGQ  180</a:t>
            </a:r>
          </a:p>
          <a:p>
            <a:endParaRPr 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Bonobo 181   SDPVVKVAVS  814</a:t>
            </a:r>
          </a:p>
          <a:p>
            <a:r>
              <a:rPr lang="en-US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             SDPVVKVA+S</a:t>
            </a:r>
          </a:p>
          <a:p>
            <a:r>
              <a:rPr lang="en-US" sz="1000" dirty="0">
                <a:latin typeface="Courier New" panose="02070309020205020404" pitchFamily="49" charset="0"/>
                <a:cs typeface="Courier New" panose="02070309020205020404" pitchFamily="49" charset="0"/>
              </a:rPr>
              <a:t>ORF3   181   SDPVVKVAIS  19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7B4C5D6-CE17-85ED-3C90-7E82F7423E4A}"/>
              </a:ext>
            </a:extLst>
          </p:cNvPr>
          <p:cNvSpPr txBox="1"/>
          <p:nvPr/>
        </p:nvSpPr>
        <p:spPr>
          <a:xfrm>
            <a:off x="453338" y="3759200"/>
            <a:ext cx="5801687" cy="3304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b="1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orilla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b="1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 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b="1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Range:1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 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orilla    VFIYLS*FISLRRSFALVAQTGVRWRNLGSPPPPLPRFKRFSCLSLPSSWD*RHVPPRPA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   V +YL  ++ LRRSFALVAQTGVRWRNLGS  PPLPRFKRFSCLSLPSSWD RHVPPRPA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ORF3   1 MYVCMYLFM</a:t>
            </a:r>
            <a:r>
              <a:rPr lang="en-US" sz="1000" u="sng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YLFLRRSFALVAQTGVRWRNLGSLQPPLPRFKRFSCLSLPSSWDYRHVPPRPA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 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orilla    </a:t>
            </a:r>
            <a:r>
              <a:rPr lang="en-US" sz="1000" kern="0" dirty="0" err="1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NFVFSIETGFLHVGRACLQLPTSGDASTSASQSDGMTGMSHRAWPivlccivlycivlyc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     +FVFSIETGFLHVGRACLQLPTSGDASTSASQSDGMTGMSHRA        ++   ++  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ORF3  63   </a:t>
            </a:r>
            <a:r>
              <a:rPr lang="en-US" sz="1000" u="sng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SFVFSIETGFLHVGRACLQLPTSGDASTSASQSDGMTGMSHRA------RRI</a:t>
            </a: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VLYCIVLY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 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orilla    </a:t>
            </a:r>
            <a:r>
              <a:rPr lang="en-US" sz="1000" kern="0" dirty="0" err="1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ivlycivlycivlyciyciyciLSYRVVSYCIVl</a:t>
            </a: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*</a:t>
            </a:r>
            <a:r>
              <a:rPr lang="en-US" sz="1000" kern="0" dirty="0" err="1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wlilfs</a:t>
            </a: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*</a:t>
            </a:r>
            <a:r>
              <a:rPr lang="en-US" sz="1000" kern="0" dirty="0" err="1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lLW</a:t>
            </a: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CYFIYLFV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     ++   ++   +L      Y I SYR+VSYCIV+  + LF  + +    FIYLFV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ORF3 117   CIVLYCIVLYRILLYCILSYPIASYRIVSYCIVMGCIDLFYLVSYFCVILFIYLFV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 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b="1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Range:2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orilla    VSYRIVLYRIVLYCNGLSYLVSYFGVILFIYLFVRSCLIKGQSDPVVKVAIS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    SYRIV Y IV+ C  L YLVSYF VILFIYLFVR CLIKGQSDPVVKVAIS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ORF3 139   ASYRIVSYCIVMGCIDLFYLVSYFCVILFIYLFVRFCLIKGQSDPVVKVAIS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endParaRPr lang="en-US" sz="10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7CB5B5E-3C95-39FC-01F9-012C63E4AE53}"/>
              </a:ext>
            </a:extLst>
          </p:cNvPr>
          <p:cNvSpPr txBox="1"/>
          <p:nvPr/>
        </p:nvSpPr>
        <p:spPr>
          <a:xfrm>
            <a:off x="241304" y="686522"/>
            <a:ext cx="64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Courier New" panose="02070309020205020404" pitchFamily="49" charset="0"/>
                <a:cs typeface="Courier New" panose="02070309020205020404" pitchFamily="49" charset="0"/>
              </a:rPr>
              <a:t>Bonobo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F254C86-E99F-36AD-06F8-69D802654D2B}"/>
              </a:ext>
            </a:extLst>
          </p:cNvPr>
          <p:cNvSpPr txBox="1"/>
          <p:nvPr/>
        </p:nvSpPr>
        <p:spPr>
          <a:xfrm>
            <a:off x="5143261" y="293906"/>
            <a:ext cx="14125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hen et al.,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. S3b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C672D51-3913-AB3E-5CE0-743F1AE14F5C}"/>
              </a:ext>
            </a:extLst>
          </p:cNvPr>
          <p:cNvSpPr txBox="1"/>
          <p:nvPr/>
        </p:nvSpPr>
        <p:spPr>
          <a:xfrm>
            <a:off x="4191488" y="16523"/>
            <a:ext cx="25811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orting Material, Chen et al page 6</a:t>
            </a:r>
          </a:p>
        </p:txBody>
      </p:sp>
    </p:spTree>
    <p:extLst>
      <p:ext uri="{BB962C8B-B14F-4D97-AF65-F5344CB8AC3E}">
        <p14:creationId xmlns:p14="http://schemas.microsoft.com/office/powerpoint/2010/main" val="346619553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9FB6282-A06D-4405-6A91-2AC351AD348B}"/>
              </a:ext>
            </a:extLst>
          </p:cNvPr>
          <p:cNvSpPr txBox="1"/>
          <p:nvPr/>
        </p:nvSpPr>
        <p:spPr>
          <a:xfrm>
            <a:off x="302172" y="293906"/>
            <a:ext cx="6350876" cy="54784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 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b="1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himpanzee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 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himp    RRSFAVFAQTGVRWRNLGSPQPPLPRFKRFSCLSLPSSWDYRHVPPRPASFVFSIETGFL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 RRSFA+ AQTGVRWRNLGS QPPLPRFKRFSCLSLPSSWDYRHVPPRPASFVFSIETGFL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ORF3  14 </a:t>
            </a:r>
            <a:r>
              <a:rPr lang="en-US" sz="1000" u="sng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RRSFALVAQTGVRWRNLGSLQPPLPRFKRFSCLSLPSSWDYRHVPPRPASFVFSIETGFL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 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 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himp    HVGRACLQLPTSGDASTSASQSDGMTGMSHRTRPIVLYCIVLYCIVLYCIL---------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 HVGRACLQLPTSGDASTSASQSDGMTGMSHR R IVLYCIVLYCIVLYCI+         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ORF3  74 </a:t>
            </a:r>
            <a:r>
              <a:rPr lang="en-US" sz="1000" u="sng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HVGRACLQLPTSGDASTSASQSDGMTGMSHRARRI</a:t>
            </a: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VLYCIVLYCIVLYCIVLYRILLYCI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 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himp    ------SYRVVFYCIAMDCIDLFYSVSYFCVILFIYLFVRFCLIKGQSDPVVKVAIS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       SYR+V YCI M CIDLFY VSYFCVILFIYLFVRFCLIKGQSDPVVKVAIS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ORF3 134 LSYPIASYRIVSYCIVMGCIDLFYLVSYFCVILFIYLFVRFCLIKGQSDPVVKVAIS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 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 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b="1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Orangutan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 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Orangutan PG*</a:t>
            </a:r>
            <a:r>
              <a:rPr lang="en-US" sz="1000" kern="0" dirty="0" err="1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FCIFNETGFPHVGQACLRLPTSGDASTSASQSDGMTGMSHRARPvvlycivlrcivl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  P  F    ETGF HVG+ACL+LPTSGDASTSASQSDGMTGMSHRAR +VLYCIVL CIVL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ORF3   61 </a:t>
            </a:r>
            <a:r>
              <a:rPr lang="en-US" sz="1000" u="sng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ASFVFSIETGFLHVGRACLQLPTSGDASTSASQSDGMTGMSHRARRI</a:t>
            </a: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VLYCIVLYCIVL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 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Orangutan </a:t>
            </a:r>
            <a:r>
              <a:rPr lang="en-US" sz="1000" kern="0" dirty="0" err="1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vv</a:t>
            </a: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*</a:t>
            </a:r>
            <a:r>
              <a:rPr lang="en-US" sz="1000" kern="0" dirty="0" err="1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rcvvlccvalyCIG</a:t>
            </a: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----------MHCIDLFYFVSYFCVILFIYVFACFCLIKGQ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   C+V   ++L C+  Y I           M CIDLFY VSYFCVILFIY+F  FCLIKGQ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ORF3  121 YCIVLYRILLYCILSYPIASYRIVSYCIVMGCIDLFYLVSYFCVILFIYLFVRFCLIKGQ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 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Orangutan SDPVVKVAIS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        SDPVVKVAIS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ORF3  181 SDPVVKVAIS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 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 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581660" algn="l"/>
                <a:tab pos="1163320" algn="l"/>
                <a:tab pos="1744980" algn="l"/>
                <a:tab pos="2326640" algn="l"/>
                <a:tab pos="2908300" algn="l"/>
                <a:tab pos="3489960" algn="l"/>
                <a:tab pos="4071620" algn="l"/>
                <a:tab pos="4653280" algn="l"/>
                <a:tab pos="5234940" algn="l"/>
                <a:tab pos="5816600" algn="l"/>
                <a:tab pos="6398260" algn="l"/>
                <a:tab pos="6979920" algn="l"/>
                <a:tab pos="7561580" algn="l"/>
                <a:tab pos="8143240" algn="l"/>
                <a:tab pos="8724900" algn="l"/>
                <a:tab pos="9306560" algn="l"/>
              </a:tabLst>
            </a:pPr>
            <a:r>
              <a:rPr lang="en-US" sz="1000" kern="0" dirty="0">
                <a:solidFill>
                  <a:srgbClr val="222222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 </a:t>
            </a:r>
            <a:endParaRPr lang="en-US" sz="1000" kern="100" dirty="0"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endParaRPr lang="en-US" sz="10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endParaRPr lang="en-US" sz="10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F08C5D3-4F30-631A-FCE1-DE12E76E3903}"/>
              </a:ext>
            </a:extLst>
          </p:cNvPr>
          <p:cNvSpPr txBox="1"/>
          <p:nvPr/>
        </p:nvSpPr>
        <p:spPr>
          <a:xfrm>
            <a:off x="5143261" y="293906"/>
            <a:ext cx="14125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hen et al.,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. S3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AA67659-A6CC-7F61-6419-9FA39520CED0}"/>
              </a:ext>
            </a:extLst>
          </p:cNvPr>
          <p:cNvSpPr txBox="1"/>
          <p:nvPr/>
        </p:nvSpPr>
        <p:spPr>
          <a:xfrm>
            <a:off x="4191488" y="16523"/>
            <a:ext cx="25811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orting Material, Chen et al page 7</a:t>
            </a:r>
          </a:p>
        </p:txBody>
      </p:sp>
    </p:spTree>
    <p:extLst>
      <p:ext uri="{BB962C8B-B14F-4D97-AF65-F5344CB8AC3E}">
        <p14:creationId xmlns:p14="http://schemas.microsoft.com/office/powerpoint/2010/main" val="53652339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black rectangle with a black background&#10;&#10;AI-generated content may be incorrect.">
            <a:extLst>
              <a:ext uri="{FF2B5EF4-FFF2-40B4-BE49-F238E27FC236}">
                <a16:creationId xmlns:a16="http://schemas.microsoft.com/office/drawing/2014/main" id="{AD1B86DD-0440-5073-9F6B-88D9C4E0D6D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3699" y="800100"/>
            <a:ext cx="2909667" cy="313105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AC08E2FD-4C20-8D9B-86B1-84A2CF88D41D}"/>
              </a:ext>
            </a:extLst>
          </p:cNvPr>
          <p:cNvSpPr txBox="1"/>
          <p:nvPr/>
        </p:nvSpPr>
        <p:spPr>
          <a:xfrm>
            <a:off x="5143261" y="293906"/>
            <a:ext cx="13340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hen et al.,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. S4</a:t>
            </a:r>
          </a:p>
        </p:txBody>
      </p:sp>
      <p:pic>
        <p:nvPicPr>
          <p:cNvPr id="2" name="Picture 3">
            <a:extLst>
              <a:ext uri="{FF2B5EF4-FFF2-40B4-BE49-F238E27FC236}">
                <a16:creationId xmlns:a16="http://schemas.microsoft.com/office/drawing/2014/main" id="{3168D9CD-8AE7-5367-AE01-570975570E8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700250" y="5048796"/>
            <a:ext cx="442913" cy="17732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7EE03D6-B651-CEFB-C33D-1AD2CB9B2DE2}"/>
              </a:ext>
            </a:extLst>
          </p:cNvPr>
          <p:cNvSpPr txBox="1"/>
          <p:nvPr/>
        </p:nvSpPr>
        <p:spPr>
          <a:xfrm rot="16200000">
            <a:off x="1383445" y="4536867"/>
            <a:ext cx="796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/>
              <a:t>Cytoplam</a:t>
            </a:r>
            <a:endParaRPr lang="en-US" sz="1200" b="1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6A365C7-B3F6-2AA0-AB61-3FA81C107B80}"/>
              </a:ext>
            </a:extLst>
          </p:cNvPr>
          <p:cNvSpPr txBox="1"/>
          <p:nvPr/>
        </p:nvSpPr>
        <p:spPr>
          <a:xfrm rot="16200000">
            <a:off x="1835149" y="4747682"/>
            <a:ext cx="3609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NE</a:t>
            </a: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3A84A4A5-40D9-6A0C-600A-81AACD666384}"/>
              </a:ext>
            </a:extLst>
          </p:cNvPr>
          <p:cNvCxnSpPr/>
          <p:nvPr/>
        </p:nvCxnSpPr>
        <p:spPr>
          <a:xfrm>
            <a:off x="1307981" y="6670890"/>
            <a:ext cx="33726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F364BF3D-22B1-0793-420F-BDDE6A46B3C3}"/>
              </a:ext>
            </a:extLst>
          </p:cNvPr>
          <p:cNvSpPr txBox="1"/>
          <p:nvPr/>
        </p:nvSpPr>
        <p:spPr>
          <a:xfrm>
            <a:off x="677603" y="6486866"/>
            <a:ext cx="7072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JH-15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F4B81B6E-8F95-5BC8-82FB-372847E78529}"/>
              </a:ext>
            </a:extLst>
          </p:cNvPr>
          <p:cNvCxnSpPr/>
          <p:nvPr/>
        </p:nvCxnSpPr>
        <p:spPr>
          <a:xfrm>
            <a:off x="1780726" y="5010203"/>
            <a:ext cx="0" cy="13631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893DFDE1-222C-2459-CF78-0E5B8D5CF171}"/>
              </a:ext>
            </a:extLst>
          </p:cNvPr>
          <p:cNvCxnSpPr/>
          <p:nvPr/>
        </p:nvCxnSpPr>
        <p:spPr>
          <a:xfrm>
            <a:off x="2015647" y="5016553"/>
            <a:ext cx="0" cy="13631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E52228FA-9BB8-5384-C336-308904F2027D}"/>
              </a:ext>
            </a:extLst>
          </p:cNvPr>
          <p:cNvSpPr txBox="1"/>
          <p:nvPr/>
        </p:nvSpPr>
        <p:spPr>
          <a:xfrm>
            <a:off x="4050919" y="691623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286A2FD-F452-CBA2-E20B-04E848B74975}"/>
              </a:ext>
            </a:extLst>
          </p:cNvPr>
          <p:cNvSpPr txBox="1"/>
          <p:nvPr/>
        </p:nvSpPr>
        <p:spPr>
          <a:xfrm>
            <a:off x="830003" y="767834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E4DDC5B-2F46-B559-C799-86E949EA87AC}"/>
              </a:ext>
            </a:extLst>
          </p:cNvPr>
          <p:cNvSpPr txBox="1"/>
          <p:nvPr/>
        </p:nvSpPr>
        <p:spPr>
          <a:xfrm>
            <a:off x="983853" y="4492805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4119C64-2C0A-A29F-3044-6C8F0CEAD10F}"/>
              </a:ext>
            </a:extLst>
          </p:cNvPr>
          <p:cNvSpPr txBox="1"/>
          <p:nvPr/>
        </p:nvSpPr>
        <p:spPr>
          <a:xfrm>
            <a:off x="4552394" y="724060"/>
            <a:ext cx="11817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ol II inhibition</a:t>
            </a:r>
          </a:p>
        </p:txBody>
      </p:sp>
      <p:pic>
        <p:nvPicPr>
          <p:cNvPr id="19" name="Picture 18" descr="Shape&#10;&#10;AI-generated content may be incorrect.">
            <a:extLst>
              <a:ext uri="{FF2B5EF4-FFF2-40B4-BE49-F238E27FC236}">
                <a16:creationId xmlns:a16="http://schemas.microsoft.com/office/drawing/2014/main" id="{7DC9342B-FD87-C7CB-A774-2F47512D03C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29000" y="952500"/>
            <a:ext cx="2590800" cy="3111500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25BFEB86-00D6-F41A-9BF9-B6E09B11B626}"/>
              </a:ext>
            </a:extLst>
          </p:cNvPr>
          <p:cNvSpPr txBox="1"/>
          <p:nvPr/>
        </p:nvSpPr>
        <p:spPr>
          <a:xfrm>
            <a:off x="4191488" y="16523"/>
            <a:ext cx="25811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orting Material, Chen et al page 8</a:t>
            </a:r>
          </a:p>
        </p:txBody>
      </p:sp>
    </p:spTree>
    <p:extLst>
      <p:ext uri="{BB962C8B-B14F-4D97-AF65-F5344CB8AC3E}">
        <p14:creationId xmlns:p14="http://schemas.microsoft.com/office/powerpoint/2010/main" val="8865253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14b77578-9773-42d5-8507-251ca2dc2b06}" enabled="0" method="" siteId="{14b77578-9773-42d5-8507-251ca2dc2b06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080</TotalTime>
  <Words>1339</Words>
  <Application>Microsoft Macintosh PowerPoint</Application>
  <PresentationFormat>Letter Paper (8.5x11 in)</PresentationFormat>
  <Paragraphs>285</Paragraphs>
  <Slides>9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7" baseType="lpstr">
      <vt:lpstr>Arial</vt:lpstr>
      <vt:lpstr>Calibri</vt:lpstr>
      <vt:lpstr>Calibri Light</vt:lpstr>
      <vt:lpstr>Courier New</vt:lpstr>
      <vt:lpstr>Symbol</vt:lpstr>
      <vt:lpstr>Times New Roman</vt:lpstr>
      <vt:lpstr>Verdana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Nagaraja, Ramaiah (NIH/NIA/IRP) [E]</dc:creator>
  <cp:keywords/>
  <dc:description/>
  <cp:lastModifiedBy>Nagaraja, Ramaiah (NIH/NIA/IRP) [E]</cp:lastModifiedBy>
  <cp:revision>8</cp:revision>
  <dcterms:created xsi:type="dcterms:W3CDTF">2024-03-12T17:14:14Z</dcterms:created>
  <dcterms:modified xsi:type="dcterms:W3CDTF">2025-08-26T13:54:21Z</dcterms:modified>
  <cp:category/>
</cp:coreProperties>
</file>